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72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F4E46-8C69-A9C3-AAEC-0925BAD6650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C18905-8F6F-C544-EA8A-B694A8EF18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5917A3-C815-B652-E69D-C9F96DACD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30348-64B8-4DDB-A33D-024B16E1EA4C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365688-A055-AFD2-CC92-3057C047D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DB05C9-5EC7-8FA4-DD97-C0FFA4A403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CB173-D375-4185-885E-2F9DCCC12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861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DAF786-7432-CBE4-FA44-F6A61F129E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E90CA7-571A-3B77-BC72-74A21C1B5B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DF82E0-53F4-27C6-DDA1-91BB77CD60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30348-64B8-4DDB-A33D-024B16E1EA4C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9B205A-6580-C28E-F599-954075E4A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E7490B-326C-3C2A-C327-2254180EF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CB173-D375-4185-885E-2F9DCCC12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144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F152BC-E3AF-4137-8959-AEDAA2D4CF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824C60-ABDE-F719-504B-1527096C71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A099D1-CB20-D104-90E8-5F552B656A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30348-64B8-4DDB-A33D-024B16E1EA4C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83FC4A-324D-BE27-81CD-0266FF6576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FF381E-ED34-9A23-E6BF-ACF944821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CB173-D375-4185-885E-2F9DCCC12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0455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6010D0-3FC6-C5C1-554E-3186C5266D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7F2144-DCD5-2367-5598-204E14E430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166A8C-A36D-FC3A-2912-92B860EB7E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30348-64B8-4DDB-A33D-024B16E1EA4C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A257D2-A23A-8C39-3B9D-0E9DC21E2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651BE2-137B-01F9-A44D-7BB850201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CB173-D375-4185-885E-2F9DCCC12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202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B19F8A-7E28-54EA-AA0F-B676CC476D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FA2D80-4185-CE13-C790-8191ACF828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29AB31-F45E-23D8-1B6B-A6F6804B7E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30348-64B8-4DDB-A33D-024B16E1EA4C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75241-0ED4-E03C-9579-6DB5601E9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C60C0C-8980-9139-EDD3-3FE451485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CB173-D375-4185-885E-2F9DCCC12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51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38F0AF-B088-3A5E-8051-CB46CF3BDE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7565AE-DFD7-7C7A-5EE1-6341D4E225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8194B4-1606-ED42-A28D-239D97AC25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5BCD99-8BB1-8F47-4458-B5E58D30B0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30348-64B8-4DDB-A33D-024B16E1EA4C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9A3E6E-5631-C74A-3238-E65CC0771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A63F02-B8CF-23C7-224A-CCFECA0013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CB173-D375-4185-885E-2F9DCCC12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572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20E280-76D3-10A1-6E42-658431238A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D3065F-F2D7-BA02-E640-823DE77089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11712A-D5E8-C3EB-BC9C-51E15C1B3D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DD6E7E5-59D1-EF71-5F19-E963FCA8F9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5A4D39-5150-F834-225A-0DF7E12061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F9B1976-A021-AECD-E565-00FD4E822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30348-64B8-4DDB-A33D-024B16E1EA4C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5C3650C-63C6-7CBB-CB1A-003B3AB9E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92F0D3D-6109-96D0-203C-A2DA0D8A3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CB173-D375-4185-885E-2F9DCCC12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397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EF4A59-E77A-4233-9F21-ED2ED9CAD3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2A2A3CA-8CA2-43DD-0C7E-B123E5A9EB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30348-64B8-4DDB-A33D-024B16E1EA4C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CCFB369-2D5D-51E9-E9FD-97A8E89D53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1D56FB3-F7E0-5647-83ED-D1D2B2671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CB173-D375-4185-885E-2F9DCCC12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2595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34C8D36-94FE-223D-9008-8954F9BED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30348-64B8-4DDB-A33D-024B16E1EA4C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4AB9816-A84C-51CD-2C1E-E5E09ADA2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86C818-3CE4-2B9C-BE91-B0D0D08F9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CB173-D375-4185-885E-2F9DCCC12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988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9D6B87-7CA2-C7DD-7A77-98657CEA3F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4B6828-1910-DAA6-B719-93580C4E5E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A0A505-ADD8-99F5-88CF-0263AAE58E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96B872-2D52-2E24-3841-BD2DC1986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30348-64B8-4DDB-A33D-024B16E1EA4C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755F17-AD16-A41B-F39D-44B5FD6E74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4EE785-4150-23C4-803D-E43908EFA1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CB173-D375-4185-885E-2F9DCCC12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291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0B2F9-0F7A-4004-C691-D8DA1FC1E2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3B609B9-D5E5-A371-B85D-0A35D24A7B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C64E37-FB5F-6480-2FAA-24BEBCB839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5A9D41-955B-10DD-F0B1-D19A2DF17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A30348-64B8-4DDB-A33D-024B16E1EA4C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6A0367-EC2E-1E4D-9096-60E839E857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71C808-F7A4-7A41-04B1-24B522789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3CB173-D375-4185-885E-2F9DCCC12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1637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75699E5-CE5D-23B2-B75C-EFE7551D04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43EA83-0E9A-0B7E-66A2-FC2C50FB16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ADA077-6ABB-874A-E2D7-D0157ACE5D1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BA30348-64B8-4DDB-A33D-024B16E1EA4C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FE78D0-5A5B-23CD-D48D-053F7E2E0A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86C37D-51B7-8452-66D1-C15655D3F3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83CB173-D375-4185-885E-2F9DCCC12D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755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>
            <a:extLst>
              <a:ext uri="{FF2B5EF4-FFF2-40B4-BE49-F238E27FC236}">
                <a16:creationId xmlns:a16="http://schemas.microsoft.com/office/drawing/2014/main" id="{C3A1324C-453C-073A-D35C-62D6FAC13F13}"/>
              </a:ext>
            </a:extLst>
          </p:cNvPr>
          <p:cNvGrpSpPr/>
          <p:nvPr/>
        </p:nvGrpSpPr>
        <p:grpSpPr>
          <a:xfrm>
            <a:off x="8018585" y="1529535"/>
            <a:ext cx="4310742" cy="4157270"/>
            <a:chOff x="7968042" y="1398147"/>
            <a:chExt cx="4310742" cy="4157270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CD1DBFE2-A27E-431C-95AA-D9A68B1B3BE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68042" y="1398147"/>
              <a:ext cx="4157270" cy="4157270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AEC4AAC-D45C-F1B2-F645-B968964731B8}"/>
                </a:ext>
              </a:extLst>
            </p:cNvPr>
            <p:cNvSpPr txBox="1"/>
            <p:nvPr/>
          </p:nvSpPr>
          <p:spPr>
            <a:xfrm>
              <a:off x="8551984" y="1720333"/>
              <a:ext cx="1535723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b="1" dirty="0"/>
                <a:t>Thiamine metabolism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19210F2-B30F-E19F-4428-C8ED1BCFF5CB}"/>
                </a:ext>
              </a:extLst>
            </p:cNvPr>
            <p:cNvSpPr txBox="1"/>
            <p:nvPr/>
          </p:nvSpPr>
          <p:spPr>
            <a:xfrm>
              <a:off x="10244830" y="1745925"/>
              <a:ext cx="203395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b="1" dirty="0"/>
                <a:t>Glycine, serine and threonine metabolism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2D1DE4F-E039-20D6-09F3-25C6DDBB591F}"/>
                </a:ext>
              </a:extLst>
            </p:cNvPr>
            <p:cNvSpPr txBox="1"/>
            <p:nvPr/>
          </p:nvSpPr>
          <p:spPr>
            <a:xfrm>
              <a:off x="8496483" y="1960557"/>
              <a:ext cx="1605695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b="1" dirty="0"/>
                <a:t>Glutathione metabolism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573BAF2-9CAA-B73E-2D22-CA285D614192}"/>
                </a:ext>
              </a:extLst>
            </p:cNvPr>
            <p:cNvSpPr txBox="1"/>
            <p:nvPr/>
          </p:nvSpPr>
          <p:spPr>
            <a:xfrm>
              <a:off x="9920288" y="2016927"/>
              <a:ext cx="2205024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b="1" dirty="0"/>
                <a:t>Taurine and </a:t>
              </a:r>
              <a:r>
                <a:rPr lang="en-US" sz="900" b="1" dirty="0" err="1"/>
                <a:t>hypotaurine</a:t>
              </a:r>
              <a:r>
                <a:rPr lang="en-US" sz="900" b="1" dirty="0"/>
                <a:t> metabolism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E67CEDAA-DA16-D2E7-3734-72B94BC44F1E}"/>
                </a:ext>
              </a:extLst>
            </p:cNvPr>
            <p:cNvSpPr txBox="1"/>
            <p:nvPr/>
          </p:nvSpPr>
          <p:spPr>
            <a:xfrm>
              <a:off x="9718431" y="2165609"/>
              <a:ext cx="2164079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b="1" dirty="0"/>
                <a:t>Cysteine and methionine metabolism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A24DB0A-E414-49F2-BF2B-EBBD19D15C8B}"/>
                </a:ext>
              </a:extLst>
            </p:cNvPr>
            <p:cNvSpPr txBox="1"/>
            <p:nvPr/>
          </p:nvSpPr>
          <p:spPr>
            <a:xfrm>
              <a:off x="8875022" y="2298904"/>
              <a:ext cx="239850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b="1" dirty="0"/>
                <a:t>Glyoxylate and dicarboxylate metabolism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FD62992-9AA5-A3A4-2F0B-BF7FAACC25D6}"/>
                </a:ext>
              </a:extLst>
            </p:cNvPr>
            <p:cNvSpPr txBox="1"/>
            <p:nvPr/>
          </p:nvSpPr>
          <p:spPr>
            <a:xfrm>
              <a:off x="8610600" y="2429707"/>
              <a:ext cx="193023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b="1" dirty="0"/>
                <a:t>Primary bile acid biosynthesis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DC6F3A7-B37C-7F1E-C342-646DF135C326}"/>
                </a:ext>
              </a:extLst>
            </p:cNvPr>
            <p:cNvSpPr txBox="1"/>
            <p:nvPr/>
          </p:nvSpPr>
          <p:spPr>
            <a:xfrm>
              <a:off x="9461433" y="2668025"/>
              <a:ext cx="1670538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b="1" dirty="0"/>
                <a:t>Arachidonic acid metabolism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1BC7E092-587A-7573-A333-510834940D18}"/>
              </a:ext>
            </a:extLst>
          </p:cNvPr>
          <p:cNvGrpSpPr/>
          <p:nvPr/>
        </p:nvGrpSpPr>
        <p:grpSpPr>
          <a:xfrm>
            <a:off x="152235" y="252046"/>
            <a:ext cx="4393975" cy="6172200"/>
            <a:chOff x="152235" y="252046"/>
            <a:chExt cx="4393975" cy="6172200"/>
          </a:xfrm>
        </p:grpSpPr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A0034F33-0C18-B83A-300F-8765E48E5B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0000"/>
            <a:stretch/>
          </p:blipFill>
          <p:spPr>
            <a:xfrm>
              <a:off x="309490" y="252046"/>
              <a:ext cx="4236720" cy="6172200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2FD77914-B537-21A5-6946-537F4E8869E0}"/>
                </a:ext>
              </a:extLst>
            </p:cNvPr>
            <p:cNvSpPr txBox="1"/>
            <p:nvPr/>
          </p:nvSpPr>
          <p:spPr>
            <a:xfrm>
              <a:off x="152235" y="252046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7668770B-6C03-3EBA-0168-17C27B8E0FFD}"/>
              </a:ext>
            </a:extLst>
          </p:cNvPr>
          <p:cNvSpPr txBox="1"/>
          <p:nvPr/>
        </p:nvSpPr>
        <p:spPr>
          <a:xfrm>
            <a:off x="4465691" y="12686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23C3521-4341-0A9A-3900-CDA78EFAFB62}"/>
              </a:ext>
            </a:extLst>
          </p:cNvPr>
          <p:cNvSpPr txBox="1"/>
          <p:nvPr/>
        </p:nvSpPr>
        <p:spPr>
          <a:xfrm>
            <a:off x="8018585" y="127392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E46A945-35F5-7E73-5910-2E41412099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55741" y="1832061"/>
            <a:ext cx="4372830" cy="3279622"/>
          </a:xfrm>
          <a:prstGeom prst="rect">
            <a:avLst/>
          </a:prstGeom>
        </p:spPr>
      </p:pic>
      <p:sp>
        <p:nvSpPr>
          <p:cNvPr id="6" name="TextBox 14">
            <a:extLst>
              <a:ext uri="{FF2B5EF4-FFF2-40B4-BE49-F238E27FC236}">
                <a16:creationId xmlns:a16="http://schemas.microsoft.com/office/drawing/2014/main" id="{4A589FD3-87EB-3FC8-48A0-D943CE613786}"/>
              </a:ext>
            </a:extLst>
          </p:cNvPr>
          <p:cNvSpPr txBox="1"/>
          <p:nvPr/>
        </p:nvSpPr>
        <p:spPr>
          <a:xfrm>
            <a:off x="9626595" y="413903"/>
            <a:ext cx="23936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 S5</a:t>
            </a:r>
          </a:p>
        </p:txBody>
      </p:sp>
    </p:spTree>
    <p:extLst>
      <p:ext uri="{BB962C8B-B14F-4D97-AF65-F5344CB8AC3E}">
        <p14:creationId xmlns:p14="http://schemas.microsoft.com/office/powerpoint/2010/main" val="1656883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35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tabolomics core TRI-HMC</dc:creator>
  <cp:lastModifiedBy>Abdul Quaiyoom Khan</cp:lastModifiedBy>
  <cp:revision>3</cp:revision>
  <dcterms:created xsi:type="dcterms:W3CDTF">2024-05-10T11:17:15Z</dcterms:created>
  <dcterms:modified xsi:type="dcterms:W3CDTF">2024-05-12T06:07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73f5887-035d-4765-8d10-97aaac8deb4a_Enabled">
    <vt:lpwstr>true</vt:lpwstr>
  </property>
  <property fmtid="{D5CDD505-2E9C-101B-9397-08002B2CF9AE}" pid="3" name="MSIP_Label_573f5887-035d-4765-8d10-97aaac8deb4a_SetDate">
    <vt:lpwstr>2024-05-12T06:07:31Z</vt:lpwstr>
  </property>
  <property fmtid="{D5CDD505-2E9C-101B-9397-08002B2CF9AE}" pid="4" name="MSIP_Label_573f5887-035d-4765-8d10-97aaac8deb4a_Method">
    <vt:lpwstr>Standard</vt:lpwstr>
  </property>
  <property fmtid="{D5CDD505-2E9C-101B-9397-08002B2CF9AE}" pid="5" name="MSIP_Label_573f5887-035d-4765-8d10-97aaac8deb4a_Name">
    <vt:lpwstr>Public</vt:lpwstr>
  </property>
  <property fmtid="{D5CDD505-2E9C-101B-9397-08002B2CF9AE}" pid="6" name="MSIP_Label_573f5887-035d-4765-8d10-97aaac8deb4a_SiteId">
    <vt:lpwstr>f08ae827-76a0-4eda-8325-df208f3835ab</vt:lpwstr>
  </property>
  <property fmtid="{D5CDD505-2E9C-101B-9397-08002B2CF9AE}" pid="7" name="MSIP_Label_573f5887-035d-4765-8d10-97aaac8deb4a_ActionId">
    <vt:lpwstr>8abeb7e9-f09c-45e5-bbbe-364a97cd95b8</vt:lpwstr>
  </property>
  <property fmtid="{D5CDD505-2E9C-101B-9397-08002B2CF9AE}" pid="8" name="MSIP_Label_573f5887-035d-4765-8d10-97aaac8deb4a_ContentBits">
    <vt:lpwstr>0</vt:lpwstr>
  </property>
</Properties>
</file>